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6" r:id="rId2"/>
    <p:sldId id="265" r:id="rId3"/>
    <p:sldId id="267" r:id="rId4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529" autoAdjust="0"/>
    <p:restoredTop sz="94364" autoAdjust="0"/>
  </p:normalViewPr>
  <p:slideViewPr>
    <p:cSldViewPr snapToGrid="0">
      <p:cViewPr varScale="1">
        <p:scale>
          <a:sx n="73" d="100"/>
          <a:sy n="73" d="100"/>
        </p:scale>
        <p:origin x="1584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8DA710-C523-4AF2-8169-3BEEB889F2CB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ABD3CD-320E-4EA2-9E26-2602A407D6D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391013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ctr"/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9311F8-7233-4E9F-8EA8-C4EFBD8850F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25846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9311F8-7233-4E9F-8EA8-C4EFBD8850F2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387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EAA82-D7D9-4651-B21D-28D358C50679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6CD-15C7-4CCA-8109-82645FF5B6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363858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EAA82-D7D9-4651-B21D-28D358C50679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6CD-15C7-4CCA-8109-82645FF5B6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6235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EAA82-D7D9-4651-B21D-28D358C50679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6CD-15C7-4CCA-8109-82645FF5B6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52910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EAA82-D7D9-4651-B21D-28D358C50679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6CD-15C7-4CCA-8109-82645FF5B6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87226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EAA82-D7D9-4651-B21D-28D358C50679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6CD-15C7-4CCA-8109-82645FF5B6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12162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EAA82-D7D9-4651-B21D-28D358C50679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6CD-15C7-4CCA-8109-82645FF5B6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24096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EAA82-D7D9-4651-B21D-28D358C50679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6CD-15C7-4CCA-8109-82645FF5B6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89913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EAA82-D7D9-4651-B21D-28D358C50679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6CD-15C7-4CCA-8109-82645FF5B6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691422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EAA82-D7D9-4651-B21D-28D358C50679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6CD-15C7-4CCA-8109-82645FF5B6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29711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EAA82-D7D9-4651-B21D-28D358C50679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6CD-15C7-4CCA-8109-82645FF5B6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77123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EAA82-D7D9-4651-B21D-28D358C50679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6CD-15C7-4CCA-8109-82645FF5B6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92225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2EAA82-D7D9-4651-B21D-28D358C50679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B6E6CD-15C7-4CCA-8109-82645FF5B6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10593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Tabla 19"/>
          <p:cNvGraphicFramePr>
            <a:graphicFrameLocks noGrp="1"/>
          </p:cNvGraphicFramePr>
          <p:nvPr>
            <p:extLst/>
          </p:nvPr>
        </p:nvGraphicFramePr>
        <p:xfrm>
          <a:off x="2048724" y="3836351"/>
          <a:ext cx="5071313" cy="1163936"/>
        </p:xfrm>
        <a:graphic>
          <a:graphicData uri="http://schemas.openxmlformats.org/drawingml/2006/table">
            <a:tbl>
              <a:tblPr firstRow="1" firstCol="1" bandRow="1"/>
              <a:tblGrid>
                <a:gridCol w="130229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0229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0229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6442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1240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 </a:t>
                      </a:r>
                      <a:endParaRPr lang="es-E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IC of heavy metals (</a:t>
                      </a:r>
                      <a:r>
                        <a:rPr lang="en-US" sz="1200" b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</a:t>
                      </a: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)</a:t>
                      </a:r>
                      <a:endParaRPr lang="es-E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5160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Strains</a:t>
                      </a:r>
                      <a:endParaRPr lang="es-E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Cl</a:t>
                      </a:r>
                      <a:r>
                        <a:rPr lang="en-GB" sz="1200" b="1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E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uSO</a:t>
                      </a:r>
                      <a:r>
                        <a:rPr lang="en-US" sz="1200" b="1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4</a:t>
                      </a:r>
                      <a:endParaRPr lang="es-E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ZnCl</a:t>
                      </a:r>
                      <a:r>
                        <a:rPr lang="en-US" sz="1200" b="1" baseline="-25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2</a:t>
                      </a:r>
                      <a:endParaRPr lang="es-ES" sz="1200" b="1" baseline="-25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3184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b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wt</a:t>
                      </a:r>
                      <a:endParaRPr lang="es-E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0.25 </a:t>
                      </a:r>
                      <a:endParaRPr lang="es-E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1.5 </a:t>
                      </a:r>
                      <a:endParaRPr lang="es-E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30</a:t>
                      </a:r>
                      <a:endParaRPr lang="es-E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3184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∆</a:t>
                      </a:r>
                      <a:r>
                        <a:rPr lang="es-ES" sz="1200" b="1" i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rpF</a:t>
                      </a:r>
                      <a:endParaRPr lang="es-ES" sz="1200" b="1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0.15 </a:t>
                      </a:r>
                      <a:endParaRPr lang="es-E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0.4 </a:t>
                      </a:r>
                      <a:endParaRPr lang="es-E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20 </a:t>
                      </a:r>
                      <a:endParaRPr lang="es-E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>
            <a:spLocks noChangeAspect="1"/>
          </p:cNvSpPr>
          <p:nvPr/>
        </p:nvSpPr>
        <p:spPr>
          <a:xfrm rot="18840000">
            <a:off x="1042736" y="1482568"/>
            <a:ext cx="1004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0.1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ES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>
            <a:spLocks noChangeAspect="1"/>
          </p:cNvSpPr>
          <p:nvPr/>
        </p:nvSpPr>
        <p:spPr>
          <a:xfrm rot="18840000">
            <a:off x="1655887" y="1482568"/>
            <a:ext cx="1004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0.15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ES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>
            <a:spLocks noChangeAspect="1"/>
          </p:cNvSpPr>
          <p:nvPr/>
        </p:nvSpPr>
        <p:spPr>
          <a:xfrm rot="18840000">
            <a:off x="2235215" y="1482568"/>
            <a:ext cx="1004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0.25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ES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>
            <a:spLocks noChangeAspect="1"/>
          </p:cNvSpPr>
          <p:nvPr/>
        </p:nvSpPr>
        <p:spPr>
          <a:xfrm rot="18840000">
            <a:off x="2763468" y="1482568"/>
            <a:ext cx="1004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0.3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endParaRPr lang="es-ES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>
            <a:spLocks noChangeAspect="1"/>
          </p:cNvSpPr>
          <p:nvPr/>
        </p:nvSpPr>
        <p:spPr>
          <a:xfrm rot="18840000">
            <a:off x="3346623" y="1558437"/>
            <a:ext cx="8007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0.3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ES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>
            <a:spLocks noChangeAspect="1"/>
          </p:cNvSpPr>
          <p:nvPr/>
        </p:nvSpPr>
        <p:spPr>
          <a:xfrm rot="18840000">
            <a:off x="3869478" y="1551455"/>
            <a:ext cx="925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0.4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ES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>
            <a:spLocks noChangeAspect="1"/>
          </p:cNvSpPr>
          <p:nvPr/>
        </p:nvSpPr>
        <p:spPr>
          <a:xfrm rot="18840000">
            <a:off x="4415442" y="1580993"/>
            <a:ext cx="811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ES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>
            <a:spLocks noChangeAspect="1"/>
          </p:cNvSpPr>
          <p:nvPr/>
        </p:nvSpPr>
        <p:spPr>
          <a:xfrm rot="18840000">
            <a:off x="4969950" y="1550041"/>
            <a:ext cx="932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1.5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endParaRPr lang="es-ES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>
            <a:spLocks noChangeAspect="1"/>
          </p:cNvSpPr>
          <p:nvPr/>
        </p:nvSpPr>
        <p:spPr>
          <a:xfrm rot="18840000">
            <a:off x="5473978" y="1550041"/>
            <a:ext cx="932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ES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>
            <a:spLocks noChangeAspect="1"/>
          </p:cNvSpPr>
          <p:nvPr/>
        </p:nvSpPr>
        <p:spPr>
          <a:xfrm rot="18840000">
            <a:off x="6101124" y="1550041"/>
            <a:ext cx="932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ES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>
            <a:spLocks noChangeAspect="1"/>
          </p:cNvSpPr>
          <p:nvPr/>
        </p:nvSpPr>
        <p:spPr>
          <a:xfrm rot="18840000">
            <a:off x="6636165" y="1550041"/>
            <a:ext cx="932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ES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>
            <a:spLocks noChangeAspect="1"/>
          </p:cNvSpPr>
          <p:nvPr/>
        </p:nvSpPr>
        <p:spPr>
          <a:xfrm rot="18840000">
            <a:off x="7215404" y="1550041"/>
            <a:ext cx="932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ES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/>
          <p:cNvSpPr>
            <a:spLocks noChangeAspect="1"/>
          </p:cNvSpPr>
          <p:nvPr/>
        </p:nvSpPr>
        <p:spPr>
          <a:xfrm>
            <a:off x="7723531" y="2747585"/>
            <a:ext cx="67197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crpF</a:t>
            </a:r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0" name="Rectangle 19"/>
          <p:cNvSpPr>
            <a:spLocks noChangeAspect="1"/>
          </p:cNvSpPr>
          <p:nvPr/>
        </p:nvSpPr>
        <p:spPr>
          <a:xfrm>
            <a:off x="7785392" y="2162566"/>
            <a:ext cx="3561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950878" y="963854"/>
            <a:ext cx="984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Cl</a:t>
            </a:r>
            <a:r>
              <a:rPr lang="es-ES" sz="14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Conector recto 18"/>
          <p:cNvCxnSpPr/>
          <p:nvPr/>
        </p:nvCxnSpPr>
        <p:spPr>
          <a:xfrm>
            <a:off x="1174884" y="1401772"/>
            <a:ext cx="20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4111333" y="963854"/>
            <a:ext cx="11731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uSO</a:t>
            </a:r>
            <a:r>
              <a:rPr lang="es-ES" sz="14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sz="1400" b="1" dirty="0"/>
          </a:p>
        </p:txBody>
      </p:sp>
      <p:cxnSp>
        <p:nvCxnSpPr>
          <p:cNvPr id="25" name="Conector recto 18"/>
          <p:cNvCxnSpPr/>
          <p:nvPr/>
        </p:nvCxnSpPr>
        <p:spPr>
          <a:xfrm>
            <a:off x="3430729" y="1401772"/>
            <a:ext cx="21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6391799" y="963854"/>
            <a:ext cx="984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ZnCl</a:t>
            </a:r>
            <a:r>
              <a:rPr lang="es-ES" sz="14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Conector recto 18"/>
          <p:cNvCxnSpPr/>
          <p:nvPr/>
        </p:nvCxnSpPr>
        <p:spPr>
          <a:xfrm>
            <a:off x="5700540" y="1401772"/>
            <a:ext cx="19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3"/>
          <p:cNvSpPr txBox="1"/>
          <p:nvPr/>
        </p:nvSpPr>
        <p:spPr>
          <a:xfrm>
            <a:off x="6756411" y="6405143"/>
            <a:ext cx="2387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sp>
        <p:nvSpPr>
          <p:cNvPr id="30" name="177 CuadroTexto"/>
          <p:cNvSpPr txBox="1"/>
          <p:nvPr/>
        </p:nvSpPr>
        <p:spPr>
          <a:xfrm>
            <a:off x="420274" y="5231621"/>
            <a:ext cx="846966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ffect of different concentration of heavy metals on wt and mutant strains growth in 96-wells plates . 30 µl of  a 10</a:t>
            </a:r>
            <a:r>
              <a:rPr lang="en-GB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spores mL</a:t>
            </a:r>
            <a:r>
              <a:rPr lang="en-GB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1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uspension</a:t>
            </a:r>
            <a:r>
              <a:rPr lang="en-GB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were inoculated in the wells containing  synthetic media (SM) supplemented with different concentrations of  CdCl</a:t>
            </a:r>
            <a:r>
              <a:rPr lang="en-GB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CuSO</a:t>
            </a:r>
            <a:r>
              <a:rPr lang="en-GB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nd ZnCl</a:t>
            </a:r>
            <a:r>
              <a:rPr lang="en-GB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nimal inhibitory concentrations (MIC) of heavy metals fo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mutant strains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F. oxysporu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31" name="CuadroTexto 5"/>
          <p:cNvSpPr txBox="1"/>
          <p:nvPr/>
        </p:nvSpPr>
        <p:spPr>
          <a:xfrm>
            <a:off x="366562" y="692000"/>
            <a:ext cx="3617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2" name="CuadroTexto 7"/>
          <p:cNvSpPr txBox="1"/>
          <p:nvPr/>
        </p:nvSpPr>
        <p:spPr>
          <a:xfrm>
            <a:off x="366562" y="3598564"/>
            <a:ext cx="3617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3" name="Imagen 3"/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61520" y="2023396"/>
            <a:ext cx="2155372" cy="576000"/>
          </a:xfrm>
          <a:prstGeom prst="rect">
            <a:avLst/>
          </a:prstGeom>
        </p:spPr>
      </p:pic>
      <p:pic>
        <p:nvPicPr>
          <p:cNvPr id="34" name="Imagen 3"/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14461" y="2027821"/>
            <a:ext cx="1097900" cy="576000"/>
          </a:xfrm>
          <a:prstGeom prst="rect">
            <a:avLst/>
          </a:prstGeom>
        </p:spPr>
      </p:pic>
      <p:pic>
        <p:nvPicPr>
          <p:cNvPr id="35" name="Imagen 3"/>
          <p:cNvPicPr>
            <a:picLocks noChangeAspect="1"/>
          </p:cNvPicPr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11175" y="2023823"/>
            <a:ext cx="549835" cy="576000"/>
          </a:xfrm>
          <a:prstGeom prst="rect">
            <a:avLst/>
          </a:prstGeom>
        </p:spPr>
      </p:pic>
      <p:pic>
        <p:nvPicPr>
          <p:cNvPr id="36" name="Imagen 3"/>
          <p:cNvPicPr>
            <a:picLocks noChangeAspect="1"/>
          </p:cNvPicPr>
          <p:nvPr/>
        </p:nvPicPr>
        <p:blipFill rotWithShape="1"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861114" y="2013065"/>
            <a:ext cx="543859" cy="576000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02101" y="2599823"/>
            <a:ext cx="1179291" cy="576000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872951" y="2580788"/>
            <a:ext cx="560836" cy="612000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422631" y="2575764"/>
            <a:ext cx="2340000" cy="620640"/>
          </a:xfrm>
          <a:prstGeom prst="rect">
            <a:avLst/>
          </a:prstGeom>
        </p:spPr>
      </p:pic>
      <p:pic>
        <p:nvPicPr>
          <p:cNvPr id="40" name="Imagen 3"/>
          <p:cNvPicPr>
            <a:picLocks noChangeAspect="1"/>
          </p:cNvPicPr>
          <p:nvPr/>
        </p:nvPicPr>
        <p:blipFill rotWithShape="1">
          <a:blip r:embed="rId1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404933" y="2013065"/>
            <a:ext cx="2340003" cy="5760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11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40004" y="2598420"/>
            <a:ext cx="2662813" cy="579815"/>
          </a:xfrm>
          <a:prstGeom prst="rect">
            <a:avLst/>
          </a:prstGeom>
        </p:spPr>
      </p:pic>
      <p:cxnSp>
        <p:nvCxnSpPr>
          <p:cNvPr id="17" name="16 Conector recto"/>
          <p:cNvCxnSpPr/>
          <p:nvPr/>
        </p:nvCxnSpPr>
        <p:spPr>
          <a:xfrm flipH="1">
            <a:off x="3204535" y="2019355"/>
            <a:ext cx="12357" cy="1145112"/>
          </a:xfrm>
          <a:prstGeom prst="line">
            <a:avLst/>
          </a:prstGeom>
          <a:ln w="12700">
            <a:solidFill>
              <a:schemeClr val="bg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/>
          <p:cNvSpPr/>
          <p:nvPr/>
        </p:nvSpPr>
        <p:spPr>
          <a:xfrm>
            <a:off x="1047318" y="2020380"/>
            <a:ext cx="6688800" cy="1152000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41" name="40 Conector recto"/>
          <p:cNvCxnSpPr/>
          <p:nvPr/>
        </p:nvCxnSpPr>
        <p:spPr>
          <a:xfrm flipH="1">
            <a:off x="5410274" y="2013065"/>
            <a:ext cx="12357" cy="1145112"/>
          </a:xfrm>
          <a:prstGeom prst="line">
            <a:avLst/>
          </a:prstGeom>
          <a:ln w="12700">
            <a:solidFill>
              <a:schemeClr val="bg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201224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3"/>
          <p:cNvSpPr txBox="1"/>
          <p:nvPr/>
        </p:nvSpPr>
        <p:spPr>
          <a:xfrm>
            <a:off x="6756411" y="6509647"/>
            <a:ext cx="2387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177 CuadroTexto"/>
          <p:cNvSpPr txBox="1"/>
          <p:nvPr/>
        </p:nvSpPr>
        <p:spPr>
          <a:xfrm>
            <a:off x="337165" y="5197758"/>
            <a:ext cx="846966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riginal Southern blot image for the identification of deletion mutant in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rpF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sing restriction enzymes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 and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ac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I that generate a wt band (7.8 kb) and deletion mutant band (3.2 kb)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 strain and 13 transformants were analysed and homologous recombination was identified in several transformants from which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3 was selected  (Δ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rpF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#33) for further analysis.  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riginal Southern blot image for the identification of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omplemented strain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rpF</a:t>
            </a:r>
            <a:r>
              <a:rPr lang="en-GB" sz="12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c 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using restriction enzymes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I and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Sa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II that generate a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eletion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utant band (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.2 kb) and an extra band of a minimum of 1,8 kb that correspond to ectopic integration. Single ectopic insertion of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rpF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gene was identified in  transformant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 #7 (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rpF</a:t>
            </a:r>
            <a:r>
              <a:rPr lang="en-GB" sz="12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#7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sz="1200" smtClean="0">
                <a:latin typeface="Arial" panose="020B0604020202020204" pitchFamily="34" charset="0"/>
                <a:cs typeface="Arial" panose="020B0604020202020204" pitchFamily="34" charset="0"/>
              </a:rPr>
              <a:t>which displayed an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tra band (approximately 6 kb)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uadroTexto 5"/>
          <p:cNvSpPr txBox="1"/>
          <p:nvPr/>
        </p:nvSpPr>
        <p:spPr>
          <a:xfrm>
            <a:off x="1318680" y="126746"/>
            <a:ext cx="3617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" name="CuadroTexto 7"/>
          <p:cNvSpPr txBox="1"/>
          <p:nvPr/>
        </p:nvSpPr>
        <p:spPr>
          <a:xfrm>
            <a:off x="1351171" y="2725002"/>
            <a:ext cx="3617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" name="1 Grupo"/>
          <p:cNvGrpSpPr/>
          <p:nvPr/>
        </p:nvGrpSpPr>
        <p:grpSpPr>
          <a:xfrm>
            <a:off x="1671925" y="267472"/>
            <a:ext cx="5135687" cy="2179628"/>
            <a:chOff x="1671925" y="574456"/>
            <a:chExt cx="5135687" cy="2179628"/>
          </a:xfrm>
        </p:grpSpPr>
        <p:grpSp>
          <p:nvGrpSpPr>
            <p:cNvPr id="11" name="Grupo 10"/>
            <p:cNvGrpSpPr>
              <a:grpSpLocks noChangeAspect="1"/>
            </p:cNvGrpSpPr>
            <p:nvPr/>
          </p:nvGrpSpPr>
          <p:grpSpPr>
            <a:xfrm>
              <a:off x="1877617" y="574456"/>
              <a:ext cx="4219539" cy="2179628"/>
              <a:chOff x="-2063931" y="1470715"/>
              <a:chExt cx="5400674" cy="2789753"/>
            </a:xfrm>
          </p:grpSpPr>
          <p:pic>
            <p:nvPicPr>
              <p:cNvPr id="2051" name="Imagen 1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5091" b="9227"/>
              <a:stretch/>
            </p:blipFill>
            <p:spPr bwMode="auto">
              <a:xfrm>
                <a:off x="-2063931" y="1470715"/>
                <a:ext cx="5400674" cy="278975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3" name="Cuadro de texto 2"/>
              <p:cNvSpPr txBox="1">
                <a:spLocks noChangeArrowheads="1"/>
              </p:cNvSpPr>
              <p:nvPr/>
            </p:nvSpPr>
            <p:spPr bwMode="auto">
              <a:xfrm rot="19426248">
                <a:off x="354553" y="1778964"/>
                <a:ext cx="573278" cy="3000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altLang="es-ES" sz="10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t</a:t>
                </a:r>
                <a:endParaRPr kumimoji="0" lang="en-GB" altLang="es-E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" name="Cuadro de texto 3"/>
              <p:cNvSpPr txBox="1">
                <a:spLocks noChangeArrowheads="1"/>
              </p:cNvSpPr>
              <p:nvPr/>
            </p:nvSpPr>
            <p:spPr bwMode="auto">
              <a:xfrm rot="19162354">
                <a:off x="-1113428" y="1592425"/>
                <a:ext cx="1052731" cy="33947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altLang="es-ES" sz="1000" b="1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#33</a:t>
                </a:r>
                <a:endParaRPr kumimoji="0" lang="en-GB" altLang="es-ES" sz="10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" name="Cuadro de texto 3"/>
            <p:cNvSpPr txBox="1">
              <a:spLocks noChangeArrowheads="1"/>
            </p:cNvSpPr>
            <p:nvPr/>
          </p:nvSpPr>
          <p:spPr bwMode="auto">
            <a:xfrm rot="19162354">
              <a:off x="2880163" y="782311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42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Cuadro de texto 3"/>
            <p:cNvSpPr txBox="1">
              <a:spLocks noChangeArrowheads="1"/>
            </p:cNvSpPr>
            <p:nvPr/>
          </p:nvSpPr>
          <p:spPr bwMode="auto">
            <a:xfrm rot="19162354">
              <a:off x="4067507" y="782311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77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Cuadro de texto 3"/>
            <p:cNvSpPr txBox="1">
              <a:spLocks noChangeArrowheads="1"/>
            </p:cNvSpPr>
            <p:nvPr/>
          </p:nvSpPr>
          <p:spPr bwMode="auto">
            <a:xfrm rot="19162354">
              <a:off x="3144771" y="782311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57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Cuadro de texto 3"/>
            <p:cNvSpPr txBox="1">
              <a:spLocks noChangeArrowheads="1"/>
            </p:cNvSpPr>
            <p:nvPr/>
          </p:nvSpPr>
          <p:spPr bwMode="auto">
            <a:xfrm rot="19162354">
              <a:off x="3377555" y="782311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60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Cuadro de texto 3"/>
            <p:cNvSpPr txBox="1">
              <a:spLocks noChangeArrowheads="1"/>
            </p:cNvSpPr>
            <p:nvPr/>
          </p:nvSpPr>
          <p:spPr bwMode="auto">
            <a:xfrm rot="19162354">
              <a:off x="3590243" y="782311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63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Cuadro de texto 3"/>
            <p:cNvSpPr txBox="1">
              <a:spLocks noChangeArrowheads="1"/>
            </p:cNvSpPr>
            <p:nvPr/>
          </p:nvSpPr>
          <p:spPr bwMode="auto">
            <a:xfrm rot="19162354">
              <a:off x="4260099" y="782311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78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Cuadro de texto 3"/>
            <p:cNvSpPr txBox="1">
              <a:spLocks noChangeArrowheads="1"/>
            </p:cNvSpPr>
            <p:nvPr/>
          </p:nvSpPr>
          <p:spPr bwMode="auto">
            <a:xfrm rot="19162354">
              <a:off x="4464749" y="782311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83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Cuadro de texto 3"/>
            <p:cNvSpPr txBox="1">
              <a:spLocks noChangeArrowheads="1"/>
            </p:cNvSpPr>
            <p:nvPr/>
          </p:nvSpPr>
          <p:spPr bwMode="auto">
            <a:xfrm rot="19162354">
              <a:off x="4709591" y="782311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97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Cuadro de texto 3"/>
            <p:cNvSpPr txBox="1">
              <a:spLocks noChangeArrowheads="1"/>
            </p:cNvSpPr>
            <p:nvPr/>
          </p:nvSpPr>
          <p:spPr bwMode="auto">
            <a:xfrm rot="19162354">
              <a:off x="4954433" y="782311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101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Cuadro de texto 3"/>
            <p:cNvSpPr txBox="1">
              <a:spLocks noChangeArrowheads="1"/>
            </p:cNvSpPr>
            <p:nvPr/>
          </p:nvSpPr>
          <p:spPr bwMode="auto">
            <a:xfrm rot="19162354">
              <a:off x="5199275" y="782311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107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Cuadro de texto 3"/>
            <p:cNvSpPr txBox="1">
              <a:spLocks noChangeArrowheads="1"/>
            </p:cNvSpPr>
            <p:nvPr/>
          </p:nvSpPr>
          <p:spPr bwMode="auto">
            <a:xfrm rot="19162354">
              <a:off x="5444115" y="782311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111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Cuadro de texto 3"/>
            <p:cNvSpPr txBox="1">
              <a:spLocks noChangeArrowheads="1"/>
            </p:cNvSpPr>
            <p:nvPr/>
          </p:nvSpPr>
          <p:spPr bwMode="auto">
            <a:xfrm rot="19162354">
              <a:off x="2368723" y="693454"/>
              <a:ext cx="832459" cy="211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5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31"/>
            <p:cNvSpPr txBox="1"/>
            <p:nvPr/>
          </p:nvSpPr>
          <p:spPr>
            <a:xfrm>
              <a:off x="6014024" y="1278757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.8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cxnSp>
          <p:nvCxnSpPr>
            <p:cNvPr id="45" name="Straight Connector 30"/>
            <p:cNvCxnSpPr/>
            <p:nvPr/>
          </p:nvCxnSpPr>
          <p:spPr>
            <a:xfrm>
              <a:off x="5925856" y="1393853"/>
              <a:ext cx="14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31"/>
            <p:cNvSpPr txBox="1"/>
            <p:nvPr/>
          </p:nvSpPr>
          <p:spPr>
            <a:xfrm>
              <a:off x="6014024" y="1707250"/>
              <a:ext cx="79358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.2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cxnSp>
          <p:nvCxnSpPr>
            <p:cNvPr id="54" name="Straight Connector 30"/>
            <p:cNvCxnSpPr/>
            <p:nvPr/>
          </p:nvCxnSpPr>
          <p:spPr>
            <a:xfrm>
              <a:off x="5925856" y="1822666"/>
              <a:ext cx="14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31"/>
            <p:cNvSpPr txBox="1"/>
            <p:nvPr/>
          </p:nvSpPr>
          <p:spPr>
            <a:xfrm>
              <a:off x="1671925" y="1006947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55" name="TextBox 31"/>
            <p:cNvSpPr txBox="1"/>
            <p:nvPr/>
          </p:nvSpPr>
          <p:spPr>
            <a:xfrm>
              <a:off x="1671925" y="1196615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56" name="TextBox 31"/>
            <p:cNvSpPr txBox="1"/>
            <p:nvPr/>
          </p:nvSpPr>
          <p:spPr>
            <a:xfrm>
              <a:off x="1671925" y="1333428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57" name="TextBox 31"/>
            <p:cNvSpPr txBox="1"/>
            <p:nvPr/>
          </p:nvSpPr>
          <p:spPr>
            <a:xfrm>
              <a:off x="1671925" y="1487981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58" name="TextBox 31"/>
            <p:cNvSpPr txBox="1"/>
            <p:nvPr/>
          </p:nvSpPr>
          <p:spPr>
            <a:xfrm>
              <a:off x="1671925" y="1612703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59" name="TextBox 31"/>
            <p:cNvSpPr txBox="1"/>
            <p:nvPr/>
          </p:nvSpPr>
          <p:spPr>
            <a:xfrm>
              <a:off x="1671925" y="1784751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60" name="TextBox 31"/>
            <p:cNvSpPr txBox="1"/>
            <p:nvPr/>
          </p:nvSpPr>
          <p:spPr>
            <a:xfrm>
              <a:off x="1671925" y="2043786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61" name="TextBox 31"/>
            <p:cNvSpPr txBox="1"/>
            <p:nvPr/>
          </p:nvSpPr>
          <p:spPr>
            <a:xfrm>
              <a:off x="1671925" y="2242442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5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</p:grpSp>
      <p:grpSp>
        <p:nvGrpSpPr>
          <p:cNvPr id="6" name="5 Grupo"/>
          <p:cNvGrpSpPr/>
          <p:nvPr/>
        </p:nvGrpSpPr>
        <p:grpSpPr>
          <a:xfrm>
            <a:off x="1797555" y="2843143"/>
            <a:ext cx="5072151" cy="2129443"/>
            <a:chOff x="1797555" y="3052153"/>
            <a:chExt cx="5072151" cy="2129443"/>
          </a:xfrm>
        </p:grpSpPr>
        <p:grpSp>
          <p:nvGrpSpPr>
            <p:cNvPr id="12" name="Grupo 11"/>
            <p:cNvGrpSpPr>
              <a:grpSpLocks noChangeAspect="1"/>
            </p:cNvGrpSpPr>
            <p:nvPr/>
          </p:nvGrpSpPr>
          <p:grpSpPr>
            <a:xfrm>
              <a:off x="1882397" y="3052153"/>
              <a:ext cx="4209978" cy="2129443"/>
              <a:chOff x="0" y="4600575"/>
              <a:chExt cx="5400675" cy="2731710"/>
            </a:xfrm>
          </p:grpSpPr>
          <p:pic>
            <p:nvPicPr>
              <p:cNvPr id="2049" name="Imagen 4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10377"/>
              <a:stretch/>
            </p:blipFill>
            <p:spPr bwMode="auto">
              <a:xfrm>
                <a:off x="0" y="4600575"/>
                <a:ext cx="5400675" cy="273171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" name="Cuadro de texto 5"/>
              <p:cNvSpPr txBox="1">
                <a:spLocks noChangeArrowheads="1"/>
              </p:cNvSpPr>
              <p:nvPr/>
            </p:nvSpPr>
            <p:spPr bwMode="auto">
              <a:xfrm rot="19162354">
                <a:off x="1477546" y="4843821"/>
                <a:ext cx="601119" cy="3394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altLang="es-ES" sz="1000" b="1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#7</a:t>
                </a:r>
                <a:endParaRPr kumimoji="0" lang="en-GB" altLang="es-ES" sz="10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1" name="Cuadro de texto 3"/>
            <p:cNvSpPr txBox="1">
              <a:spLocks noChangeArrowheads="1"/>
            </p:cNvSpPr>
            <p:nvPr/>
          </p:nvSpPr>
          <p:spPr bwMode="auto">
            <a:xfrm rot="19162354">
              <a:off x="2759189" y="3145856"/>
              <a:ext cx="756322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4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Cuadro de texto 3"/>
            <p:cNvSpPr txBox="1">
              <a:spLocks noChangeArrowheads="1"/>
            </p:cNvSpPr>
            <p:nvPr/>
          </p:nvSpPr>
          <p:spPr bwMode="auto">
            <a:xfrm rot="19162354">
              <a:off x="4229955" y="3216432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37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Cuadro de texto 3"/>
            <p:cNvSpPr txBox="1">
              <a:spLocks noChangeArrowheads="1"/>
            </p:cNvSpPr>
            <p:nvPr/>
          </p:nvSpPr>
          <p:spPr bwMode="auto">
            <a:xfrm rot="19162354">
              <a:off x="3297171" y="3216432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11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Cuadro de texto 3"/>
            <p:cNvSpPr txBox="1">
              <a:spLocks noChangeArrowheads="1"/>
            </p:cNvSpPr>
            <p:nvPr/>
          </p:nvSpPr>
          <p:spPr bwMode="auto">
            <a:xfrm rot="19162354">
              <a:off x="3550051" y="3216432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14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Cuadro de texto 3"/>
            <p:cNvSpPr txBox="1">
              <a:spLocks noChangeArrowheads="1"/>
            </p:cNvSpPr>
            <p:nvPr/>
          </p:nvSpPr>
          <p:spPr bwMode="auto">
            <a:xfrm rot="19162354">
              <a:off x="3762739" y="3216432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17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Cuadro de texto 3"/>
            <p:cNvSpPr txBox="1">
              <a:spLocks noChangeArrowheads="1"/>
            </p:cNvSpPr>
            <p:nvPr/>
          </p:nvSpPr>
          <p:spPr bwMode="auto">
            <a:xfrm rot="19162354">
              <a:off x="4452691" y="3216432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43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Cuadro de texto 3"/>
            <p:cNvSpPr txBox="1">
              <a:spLocks noChangeArrowheads="1"/>
            </p:cNvSpPr>
            <p:nvPr/>
          </p:nvSpPr>
          <p:spPr bwMode="auto">
            <a:xfrm rot="19162354">
              <a:off x="4687485" y="3216432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57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Cuadro de texto 3"/>
            <p:cNvSpPr txBox="1">
              <a:spLocks noChangeArrowheads="1"/>
            </p:cNvSpPr>
            <p:nvPr/>
          </p:nvSpPr>
          <p:spPr bwMode="auto">
            <a:xfrm rot="19162354">
              <a:off x="4932327" y="3216432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68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Cuadro de texto 3"/>
            <p:cNvSpPr txBox="1">
              <a:spLocks noChangeArrowheads="1"/>
            </p:cNvSpPr>
            <p:nvPr/>
          </p:nvSpPr>
          <p:spPr bwMode="auto">
            <a:xfrm rot="19162354">
              <a:off x="5177169" y="3216432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82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Cuadro de texto 3"/>
            <p:cNvSpPr txBox="1">
              <a:spLocks noChangeArrowheads="1"/>
            </p:cNvSpPr>
            <p:nvPr/>
          </p:nvSpPr>
          <p:spPr bwMode="auto">
            <a:xfrm rot="19162354">
              <a:off x="5422011" y="3216432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99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Cuadro de texto 3"/>
            <p:cNvSpPr txBox="1">
              <a:spLocks noChangeArrowheads="1"/>
            </p:cNvSpPr>
            <p:nvPr/>
          </p:nvSpPr>
          <p:spPr bwMode="auto">
            <a:xfrm rot="19162354">
              <a:off x="5666851" y="3216432"/>
              <a:ext cx="539544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107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Cuadro de texto 3"/>
            <p:cNvSpPr txBox="1">
              <a:spLocks noChangeArrowheads="1"/>
            </p:cNvSpPr>
            <p:nvPr/>
          </p:nvSpPr>
          <p:spPr bwMode="auto">
            <a:xfrm rot="19162354">
              <a:off x="2451217" y="3090157"/>
              <a:ext cx="960840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Δ</a:t>
              </a:r>
              <a:r>
                <a:rPr kumimoji="0" lang="es-ES" altLang="es-ES" sz="1000" b="1" i="1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rpF</a:t>
              </a: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33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Cuadro de texto 3"/>
            <p:cNvSpPr txBox="1">
              <a:spLocks noChangeArrowheads="1"/>
            </p:cNvSpPr>
            <p:nvPr/>
          </p:nvSpPr>
          <p:spPr bwMode="auto">
            <a:xfrm rot="19162354">
              <a:off x="3979927" y="3162377"/>
              <a:ext cx="705575" cy="265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#23</a:t>
              </a:r>
              <a:endParaRPr kumimoji="0" lang="en-GB" alt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31"/>
            <p:cNvSpPr txBox="1"/>
            <p:nvPr/>
          </p:nvSpPr>
          <p:spPr>
            <a:xfrm>
              <a:off x="6058733" y="4154464"/>
              <a:ext cx="8109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.2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cxnSp>
          <p:nvCxnSpPr>
            <p:cNvPr id="52" name="Straight Connector 30"/>
            <p:cNvCxnSpPr/>
            <p:nvPr/>
          </p:nvCxnSpPr>
          <p:spPr>
            <a:xfrm>
              <a:off x="5976195" y="4266733"/>
              <a:ext cx="14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31"/>
            <p:cNvSpPr txBox="1"/>
            <p:nvPr/>
          </p:nvSpPr>
          <p:spPr>
            <a:xfrm>
              <a:off x="1797555" y="3493849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63" name="TextBox 31"/>
            <p:cNvSpPr txBox="1"/>
            <p:nvPr/>
          </p:nvSpPr>
          <p:spPr>
            <a:xfrm>
              <a:off x="1797555" y="3616280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64" name="TextBox 31"/>
            <p:cNvSpPr txBox="1"/>
            <p:nvPr/>
          </p:nvSpPr>
          <p:spPr>
            <a:xfrm>
              <a:off x="1797555" y="3724681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65" name="TextBox 31"/>
            <p:cNvSpPr txBox="1"/>
            <p:nvPr/>
          </p:nvSpPr>
          <p:spPr>
            <a:xfrm>
              <a:off x="1797555" y="3834829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66" name="TextBox 31"/>
            <p:cNvSpPr txBox="1"/>
            <p:nvPr/>
          </p:nvSpPr>
          <p:spPr>
            <a:xfrm>
              <a:off x="1797555" y="3941172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67" name="TextBox 31"/>
            <p:cNvSpPr txBox="1"/>
            <p:nvPr/>
          </p:nvSpPr>
          <p:spPr>
            <a:xfrm>
              <a:off x="1797555" y="4066265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68" name="TextBox 31"/>
            <p:cNvSpPr txBox="1"/>
            <p:nvPr/>
          </p:nvSpPr>
          <p:spPr>
            <a:xfrm>
              <a:off x="1797555" y="4252272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69" name="TextBox 31"/>
            <p:cNvSpPr txBox="1"/>
            <p:nvPr/>
          </p:nvSpPr>
          <p:spPr>
            <a:xfrm>
              <a:off x="1797555" y="4407849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5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70" name="TextBox 31"/>
            <p:cNvSpPr txBox="1"/>
            <p:nvPr/>
          </p:nvSpPr>
          <p:spPr>
            <a:xfrm>
              <a:off x="1797555" y="4718401"/>
              <a:ext cx="580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 kb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410813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a 2"/>
          <p:cNvGraphicFramePr>
            <a:graphicFrameLocks noGrp="1"/>
          </p:cNvGraphicFramePr>
          <p:nvPr>
            <p:extLst/>
          </p:nvPr>
        </p:nvGraphicFramePr>
        <p:xfrm>
          <a:off x="295022" y="124774"/>
          <a:ext cx="8509944" cy="5659041"/>
        </p:xfrm>
        <a:graphic>
          <a:graphicData uri="http://schemas.openxmlformats.org/drawingml/2006/table">
            <a:tbl>
              <a:tblPr firstRow="1" firstCol="1" bandRow="1">
                <a:tableStyleId>{68D230F3-CF80-4859-8CE7-A43EE81993B5}</a:tableStyleId>
              </a:tblPr>
              <a:tblGrid>
                <a:gridCol w="129692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7575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373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40329">
                  <a:extLst>
                    <a:ext uri="{9D8B030D-6E8A-4147-A177-3AD203B41FA5}">
                      <a16:colId xmlns:a16="http://schemas.microsoft.com/office/drawing/2014/main" val="3770163861"/>
                    </a:ext>
                  </a:extLst>
                </a:gridCol>
                <a:gridCol w="1184480">
                  <a:extLst>
                    <a:ext uri="{9D8B030D-6E8A-4147-A177-3AD203B41FA5}">
                      <a16:colId xmlns:a16="http://schemas.microsoft.com/office/drawing/2014/main" val="73239827"/>
                    </a:ext>
                  </a:extLst>
                </a:gridCol>
                <a:gridCol w="90955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36553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288176">
                <a:tc gridSpan="7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400" b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eavy-metal ATPases (HMA) </a:t>
                      </a:r>
                      <a:endParaRPr lang="es-E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5256">
                <a:tc gridSpan="7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2-type</a:t>
                      </a:r>
                      <a:endParaRPr lang="es-ES" sz="9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5256"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 </a:t>
                      </a:r>
                      <a:r>
                        <a:rPr lang="en-GB" sz="9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. oxysporum</a:t>
                      </a:r>
                      <a:endParaRPr lang="es-ES" sz="9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. fumigatus</a:t>
                      </a:r>
                      <a:endParaRPr lang="es-ES" sz="900" b="1" i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. cerevisiae</a:t>
                      </a:r>
                      <a:endParaRPr lang="es-ES" sz="900" b="1" i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 i="1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 </a:t>
                      </a:r>
                      <a:r>
                        <a:rPr lang="en-GB" sz="900" b="1" i="1" u="non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oformans</a:t>
                      </a:r>
                      <a:endParaRPr lang="es-ES" sz="900" b="1" i="1" u="none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 </a:t>
                      </a:r>
                      <a:r>
                        <a:rPr lang="en-GB" sz="900" b="1" i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assa</a:t>
                      </a:r>
                      <a:endParaRPr lang="es-ES" sz="900" b="1" i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 </a:t>
                      </a:r>
                      <a:r>
                        <a:rPr lang="es-ES" sz="900" b="1" i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bicans</a:t>
                      </a:r>
                      <a:endParaRPr lang="es-ES" sz="900" b="1" i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Function</a:t>
                      </a:r>
                      <a:endParaRPr lang="es-ES" sz="9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525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G_11217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tA</a:t>
                      </a: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AfuA_4G12620) 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2p (AAC37425.1)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2 </a:t>
                      </a: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 (XP_012053482.1)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s-ES" sz="9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P1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NCU08341)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kern="1200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2</a:t>
                      </a:r>
                      <a:r>
                        <a:rPr lang="es-ES" sz="9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900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KGQ85259.1)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racellular copper ATPase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2905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OXG_12226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9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 smtClean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9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 smtClean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9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 smtClean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9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 smtClean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9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---</a:t>
                      </a:r>
                      <a:endParaRPr lang="es-ES" sz="900" dirty="0" smtClean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known function</a:t>
                      </a:r>
                      <a:endParaRPr lang="es-ES" sz="900" dirty="0" smtClean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25256">
                <a:tc gridSpan="7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p</a:t>
                      </a:r>
                      <a:r>
                        <a:rPr lang="en-GB" sz="9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type</a:t>
                      </a: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2525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G_03265</a:t>
                      </a:r>
                      <a:r>
                        <a:rPr lang="en-GB" sz="9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</a:t>
                      </a:r>
                      <a:endParaRPr lang="es-ES" sz="9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 err="1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pA</a:t>
                      </a:r>
                      <a:r>
                        <a:rPr lang="es-ES" sz="900" b="1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fuA_3G12740)</a:t>
                      </a:r>
                      <a:r>
                        <a:rPr lang="es-ES" sz="9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kern="1200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pper </a:t>
                      </a:r>
                      <a:r>
                        <a:rPr lang="en-GB" sz="900" kern="12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istance-associated P-type ATPase</a:t>
                      </a:r>
                    </a:p>
                    <a:p>
                      <a:pPr marL="0" marR="0" indent="0" algn="ct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kern="1200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CU04076)</a:t>
                      </a:r>
                      <a:endParaRPr lang="en-GB" sz="900" noProof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kern="1200" cap="all" baseline="0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s-ES" sz="900" b="1" kern="1200" cap="none" baseline="0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</a:t>
                      </a:r>
                      <a:r>
                        <a:rPr lang="es-ES" sz="900" b="1" kern="1200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es-ES" sz="900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AAF04593.1)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pper-exporting ATPase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25256">
                <a:tc gridSpan="7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a</a:t>
                      </a:r>
                      <a:r>
                        <a:rPr lang="en-GB" sz="9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type</a:t>
                      </a: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49782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OXG_13067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--</a:t>
                      </a:r>
                      <a:endParaRPr lang="es-ES" dirty="0"/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9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known function</a:t>
                      </a:r>
                      <a:endParaRPr lang="es-ES" sz="900" dirty="0" smtClean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879631661"/>
                  </a:ext>
                </a:extLst>
              </a:tr>
              <a:tr h="576186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OXG_08388</a:t>
                      </a:r>
                    </a:p>
                  </a:txBody>
                  <a:tcPr marL="67954" marR="67954" marT="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kern="1200" dirty="0" err="1" smtClean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caA</a:t>
                      </a:r>
                      <a:r>
                        <a:rPr lang="es-ES" sz="900" b="1" kern="1200" dirty="0" smtClean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AFUA_1G16130)</a:t>
                      </a:r>
                      <a:r>
                        <a:rPr lang="es-ES" sz="900" baseline="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900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s-ES" sz="900" dirty="0" smtClean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P_009854.2 </a:t>
                      </a:r>
                      <a:r>
                        <a:rPr lang="es-ES" sz="900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s-ES" sz="900" dirty="0" smtClean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9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 smtClean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CU07531) </a:t>
                      </a:r>
                      <a:endPara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 smtClean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-type Cu</a:t>
                      </a:r>
                      <a:r>
                        <a:rPr lang="en-US" sz="90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or Cd </a:t>
                      </a: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TPase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25256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OXG_02854</a:t>
                      </a:r>
                      <a:endParaRPr lang="es-ES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--</a:t>
                      </a:r>
                      <a:endParaRPr lang="es-ES" dirty="0"/>
                    </a:p>
                  </a:txBody>
                  <a:tcPr marL="67954" marR="6795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9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known function</a:t>
                      </a:r>
                      <a:endParaRPr lang="es-ES" sz="900" dirty="0" smtClean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16053810"/>
                  </a:ext>
                </a:extLst>
              </a:tr>
              <a:tr h="225256">
                <a:tc gridSpan="7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</a:t>
                      </a:r>
                      <a:r>
                        <a:rPr lang="en-GB" sz="900" b="1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</a:t>
                      </a:r>
                      <a:r>
                        <a:rPr lang="en-GB" sz="9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evant copper-binding proteins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>
                        <a:alpha val="2000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731220604"/>
                  </a:ext>
                </a:extLst>
              </a:tr>
              <a:tr h="35828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G_03101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A2 (AfuA_6G02810) *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tr1p </a:t>
                      </a:r>
                      <a:r>
                        <a:rPr lang="es-ES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*</a:t>
                      </a: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1</a:t>
                      </a: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U-3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CU07428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kern="1200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1</a:t>
                      </a:r>
                      <a:r>
                        <a:rPr lang="es-ES" sz="9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h-affinity </a:t>
                      </a: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pper transporter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629080494"/>
                  </a:ext>
                </a:extLst>
              </a:tr>
              <a:tr h="3751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300"/>
                        </a:spcAft>
                      </a:pPr>
                      <a:r>
                        <a:rPr lang="en-GB" sz="9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G_07770/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300"/>
                        </a:spcAft>
                      </a:pPr>
                      <a:r>
                        <a:rPr lang="en-GB" sz="9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G_01107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C</a:t>
                      </a: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fuA_2G03730) *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3p *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4</a:t>
                      </a: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s-ES" sz="9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U-1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CU00830</a:t>
                      </a:r>
                    </a:p>
                  </a:txBody>
                  <a:tcPr marL="67954" marR="67954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4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h-affinity </a:t>
                      </a: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pper transporter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2317890"/>
                  </a:ext>
                </a:extLst>
              </a:tr>
              <a:tr h="22525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G_01748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2 (AfuA_3G08180)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2p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2</a:t>
                      </a: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s-ES" sz="9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U-2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CU03281</a:t>
                      </a:r>
                    </a:p>
                  </a:txBody>
                  <a:tcPr marL="67954" marR="6795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2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w-affinity </a:t>
                      </a: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pper transporter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/>
                </a:tc>
                <a:extLst>
                  <a:ext uri="{0D108BD9-81ED-4DB2-BD59-A6C34878D82A}">
                    <a16:rowId xmlns:a16="http://schemas.microsoft.com/office/drawing/2014/main" val="3690667253"/>
                  </a:ext>
                </a:extLst>
              </a:tr>
              <a:tr h="3771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A1 (</a:t>
                      </a: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uA_3G13660)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1p *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9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indent="0" algn="ct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known </a:t>
                      </a: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nction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954" marR="6795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9973318"/>
                  </a:ext>
                </a:extLst>
              </a:tr>
            </a:tbl>
          </a:graphicData>
        </a:graphic>
      </p:graphicFrame>
      <p:sp>
        <p:nvSpPr>
          <p:cNvPr id="5" name="177 CuadroTexto"/>
          <p:cNvSpPr txBox="1"/>
          <p:nvPr/>
        </p:nvSpPr>
        <p:spPr>
          <a:xfrm>
            <a:off x="295022" y="5867118"/>
            <a:ext cx="846966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avy-metal ATPases and other relevant copper transporters in </a:t>
            </a:r>
            <a:r>
              <a:rPr lang="en-GB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F. oxysporum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Orthologous genes were identified through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ASTp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earches at NCBI database (http://www.ncbi.nlm.nih.gov/blast) and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F. oxysporum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enome database (https://genome.jgi.doe.gov/Fusox1/Fusox1.home.html). Mutant strains generated in these genes are indicated (*). Genes that have been shown to be involved in virulence are highlighted in blue.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87871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11</TotalTime>
  <Words>615</Words>
  <Application>Microsoft Office PowerPoint</Application>
  <PresentationFormat>Presentación en pantalla (4:3)</PresentationFormat>
  <Paragraphs>192</Paragraphs>
  <Slides>3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Dàmaris Lorenzo Gutiérrez</dc:creator>
  <cp:lastModifiedBy>Dàmaris Lorenzo Gutiérrez</cp:lastModifiedBy>
  <cp:revision>76</cp:revision>
  <dcterms:created xsi:type="dcterms:W3CDTF">2020-04-18T14:53:16Z</dcterms:created>
  <dcterms:modified xsi:type="dcterms:W3CDTF">2020-07-27T09:57:05Z</dcterms:modified>
</cp:coreProperties>
</file>